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8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560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493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453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315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752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531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663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888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771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85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38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752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10681" y="378824"/>
            <a:ext cx="41696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655303" y="2743201"/>
            <a:ext cx="1524000" cy="3810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>
                <a:solidFill>
                  <a:schemeClr val="tx1"/>
                </a:solidFill>
              </a:rPr>
              <a:t>Informed consent, screening</a:t>
            </a:r>
            <a:endParaRPr lang="en-US" sz="1400" dirty="0">
              <a:solidFill>
                <a:schemeClr val="tx1"/>
              </a:solidFill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3179302" y="2743200"/>
          <a:ext cx="541020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01700"/>
                <a:gridCol w="901700"/>
                <a:gridCol w="901700"/>
                <a:gridCol w="901700"/>
                <a:gridCol w="1803400"/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Cycle</a:t>
                      </a:r>
                      <a:r>
                        <a:rPr lang="en-US" baseline="0" dirty="0" smtClean="0">
                          <a:solidFill>
                            <a:schemeClr val="tx1"/>
                          </a:solidFill>
                        </a:rPr>
                        <a:t> 1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Cycle 2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Cycle 3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Cycle 4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</a:rPr>
                        <a:t>Observation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698380" y="1274580"/>
            <a:ext cx="1301703" cy="683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18288" tIns="18288" rIns="18288" bIns="18288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1, D3 vaccine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te biopsy,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lood collection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3283163" y="1953886"/>
            <a:ext cx="0" cy="771118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6005770" y="1915796"/>
            <a:ext cx="0" cy="809209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ight Brace 11"/>
          <p:cNvSpPr/>
          <p:nvPr/>
        </p:nvSpPr>
        <p:spPr>
          <a:xfrm rot="16200000" flipH="1">
            <a:off x="5575808" y="759017"/>
            <a:ext cx="609599" cy="5402606"/>
          </a:xfrm>
          <a:prstGeom prst="rightBrace">
            <a:avLst>
              <a:gd name="adj1" fmla="val 181307"/>
              <a:gd name="adj2" fmla="val 49848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5426652" y="3716791"/>
            <a:ext cx="9204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month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229499" y="1274580"/>
            <a:ext cx="1301703" cy="683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18288" tIns="18288" rIns="18288" bIns="18288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4, D3 vaccine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te biopsy,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lood collection</a:t>
            </a:r>
          </a:p>
        </p:txBody>
      </p:sp>
      <p:sp>
        <p:nvSpPr>
          <p:cNvPr id="15" name="Rectangle 14"/>
          <p:cNvSpPr/>
          <p:nvPr/>
        </p:nvSpPr>
        <p:spPr>
          <a:xfrm>
            <a:off x="8589503" y="2743200"/>
            <a:ext cx="1524000" cy="3810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>
                <a:solidFill>
                  <a:schemeClr val="tx1"/>
                </a:solidFill>
              </a:rPr>
              <a:t>5-year long-term follow-up</a:t>
            </a:r>
            <a:endParaRPr lang="en-US" sz="1400" dirty="0">
              <a:solidFill>
                <a:schemeClr val="tx1"/>
              </a:solidFill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 flipV="1">
            <a:off x="3104100" y="3135421"/>
            <a:ext cx="0" cy="699589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903554" y="3760795"/>
            <a:ext cx="23903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adiologic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Body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T scans, brai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RI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426653" y="3822974"/>
            <a:ext cx="23903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adiologic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Body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T scans, brai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RI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21" name="Straight Arrow Connector 20"/>
          <p:cNvCxnSpPr/>
          <p:nvPr/>
        </p:nvCxnSpPr>
        <p:spPr>
          <a:xfrm flipV="1">
            <a:off x="8621820" y="3129810"/>
            <a:ext cx="0" cy="769548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ight Arrow 23"/>
          <p:cNvSpPr/>
          <p:nvPr/>
        </p:nvSpPr>
        <p:spPr>
          <a:xfrm>
            <a:off x="9982201" y="2543226"/>
            <a:ext cx="630697" cy="780951"/>
          </a:xfrm>
          <a:prstGeom prst="rightArrow">
            <a:avLst>
              <a:gd name="adj1" fmla="val 50000"/>
              <a:gd name="adj2" fmla="val 75868"/>
            </a:avLst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4" name="Straight Arrow Connector 53"/>
          <p:cNvCxnSpPr/>
          <p:nvPr/>
        </p:nvCxnSpPr>
        <p:spPr>
          <a:xfrm>
            <a:off x="6777146" y="2456950"/>
            <a:ext cx="0" cy="286251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8592438" y="2482972"/>
            <a:ext cx="0" cy="260228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>
            <a:off x="5771094" y="2476633"/>
            <a:ext cx="0" cy="260228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4727454" y="2137950"/>
            <a:ext cx="260584" cy="24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27432" tIns="27432" rIns="27432" bIns="27432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cxnSp>
        <p:nvCxnSpPr>
          <p:cNvPr id="64" name="Straight Arrow Connector 63"/>
          <p:cNvCxnSpPr/>
          <p:nvPr/>
        </p:nvCxnSpPr>
        <p:spPr>
          <a:xfrm>
            <a:off x="4885247" y="2470812"/>
            <a:ext cx="0" cy="260228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3909513" y="2136724"/>
            <a:ext cx="260584" cy="24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27432" tIns="27432" rIns="27432" bIns="27432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cxnSp>
        <p:nvCxnSpPr>
          <p:cNvPr id="66" name="Straight Arrow Connector 65"/>
          <p:cNvCxnSpPr/>
          <p:nvPr/>
        </p:nvCxnSpPr>
        <p:spPr>
          <a:xfrm>
            <a:off x="4004433" y="2471027"/>
            <a:ext cx="0" cy="260228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>
            <a:off x="3071713" y="2488434"/>
            <a:ext cx="0" cy="236571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2926507" y="2130959"/>
            <a:ext cx="260584" cy="24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27432" tIns="27432" rIns="27432" bIns="27432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5640802" y="2143838"/>
            <a:ext cx="260584" cy="24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27432" tIns="27432" rIns="27432" bIns="27432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6646854" y="2143715"/>
            <a:ext cx="260584" cy="24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27432" tIns="27432" rIns="27432" bIns="27432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8464785" y="2158228"/>
            <a:ext cx="260584" cy="24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27432" tIns="27432" rIns="27432" bIns="27432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997202" y="2374462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*</a:t>
            </a:r>
            <a:endParaRPr lang="en-US" sz="28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5711072" y="2374462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*</a:t>
            </a:r>
            <a:endParaRPr lang="en-US" sz="28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4805937" y="2396500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*</a:t>
            </a:r>
            <a:endParaRPr lang="en-US" sz="28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3941533" y="2387341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*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2413911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9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Johns Hopkin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Carrie Gardner</dc:creator>
  <cp:lastModifiedBy>Carrie Gardner</cp:lastModifiedBy>
  <cp:revision>8</cp:revision>
  <dcterms:created xsi:type="dcterms:W3CDTF">2015-04-07T17:36:43Z</dcterms:created>
  <dcterms:modified xsi:type="dcterms:W3CDTF">2015-04-07T17:42:15Z</dcterms:modified>
</cp:coreProperties>
</file>